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852" y="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F92AD-C441-4F9A-95C2-C4258DAD5E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35479-073C-45F0-BFF5-2952F53A68D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04800" y="4985266"/>
            <a:ext cx="86106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Additional fil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itchFamily="18" charset="0"/>
                <a:cs typeface="Arial" panose="020B0604020202020204" pitchFamily="34" charset="0"/>
              </a:rPr>
              <a:t>3: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tofluorescence of curcumin in C6 cells. (A) 5 µM CUR produced fluorescence in live C6 cells and persisted within cells for at least 24 hrs. (B) Cells were methanol-fixed 24 hrs after 5 µM CUR treatment and were stained with Hoechst nuclear stain (red). Both cytoplasmic and nuclear curcumin localization was observed (green)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dditional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1000"/>
            <a:ext cx="9027566" cy="445983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6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apurna sarma</dc:creator>
  <cp:lastModifiedBy>Michael Eric Geusz</cp:lastModifiedBy>
  <cp:revision>9</cp:revision>
  <dcterms:created xsi:type="dcterms:W3CDTF">2016-02-23T04:09:54Z</dcterms:created>
  <dcterms:modified xsi:type="dcterms:W3CDTF">2016-07-21T02:56:57Z</dcterms:modified>
</cp:coreProperties>
</file>